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7.png" ContentType="image/png"/>
  <Override PartName="/ppt/media/image8.jpeg" ContentType="image/jpeg"/>
  <Override PartName="/ppt/media/image13.jpeg" ContentType="image/jpeg"/>
  <Override PartName="/ppt/media/image9.jpeg" ContentType="image/jpeg"/>
  <Override PartName="/ppt/media/image11.png" ContentType="image/png"/>
  <Override PartName="/ppt/media/image1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3716000" cy="144033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2F260-99BB-4255-B52A-DEDC050FA2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576000"/>
            <a:ext cx="123458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3360240"/>
            <a:ext cx="1234584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8324640"/>
            <a:ext cx="1234584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D80E04-7997-4613-BB0F-C46BBAE7A1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576000"/>
            <a:ext cx="123458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3360240"/>
            <a:ext cx="6024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2080" y="3360240"/>
            <a:ext cx="6024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8324640"/>
            <a:ext cx="6024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2080" y="8324640"/>
            <a:ext cx="6024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70012E-352C-4D75-B085-DDAB2D6298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576000"/>
            <a:ext cx="123458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3360240"/>
            <a:ext cx="397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60000" y="3360240"/>
            <a:ext cx="397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4200" y="3360240"/>
            <a:ext cx="397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8324640"/>
            <a:ext cx="397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60000" y="8324640"/>
            <a:ext cx="397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4200" y="8324640"/>
            <a:ext cx="397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D248E-9B87-43F6-AE24-CA8386A7D6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576000"/>
            <a:ext cx="123458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3360240"/>
            <a:ext cx="12345840" cy="9504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57222A-B6CE-4D89-A603-DC89DA9A59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576000"/>
            <a:ext cx="123458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3360240"/>
            <a:ext cx="1234584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0A001-3BBA-44AF-97E3-9E14975C5E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576000"/>
            <a:ext cx="123458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3360240"/>
            <a:ext cx="60246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2080" y="3360240"/>
            <a:ext cx="60246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E2FE5C-3095-4847-8E52-1DADAB4AC7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576000"/>
            <a:ext cx="123458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CD259-F357-4C83-9D71-BB91A7F638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576000"/>
            <a:ext cx="12345840" cy="11126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6F9CCC-4561-484C-851E-5F0BFA5A54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576000"/>
            <a:ext cx="123458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3360240"/>
            <a:ext cx="6024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2080" y="3360240"/>
            <a:ext cx="60246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8324640"/>
            <a:ext cx="6024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B83C81-9BB5-4262-A6D6-17D8F41EE5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576000"/>
            <a:ext cx="123458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3360240"/>
            <a:ext cx="60246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2080" y="3360240"/>
            <a:ext cx="6024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2080" y="8324640"/>
            <a:ext cx="6024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9D5330-54BD-4B56-B1E1-3A0AF7F070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576000"/>
            <a:ext cx="123458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3360240"/>
            <a:ext cx="6024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2080" y="3360240"/>
            <a:ext cx="6024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8324640"/>
            <a:ext cx="1234584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1A06E-6E34-404D-9266-E496A308AA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576000"/>
            <a:ext cx="123458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3360240"/>
            <a:ext cx="1234584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3115880"/>
            <a:ext cx="3200400" cy="99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6120" y="13115880"/>
            <a:ext cx="4344840" cy="99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31240" y="13115880"/>
            <a:ext cx="3200400" cy="99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94E9D5-A92E-4B05-A83B-08A36377C906}" type="slidenum">
              <a:rPr b="0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7.png"/><Relationship Id="rId9" Type="http://schemas.openxmlformats.org/officeDocument/2006/relationships/image" Target="../media/image8.jpeg"/><Relationship Id="rId10" Type="http://schemas.openxmlformats.org/officeDocument/2006/relationships/image" Target="../media/image9.jpeg"/><Relationship Id="rId11" Type="http://schemas.openxmlformats.org/officeDocument/2006/relationships/image" Target="../media/image10.jpeg"/><Relationship Id="rId12" Type="http://schemas.openxmlformats.org/officeDocument/2006/relationships/image" Target="../media/image11.png"/><Relationship Id="rId13" Type="http://schemas.openxmlformats.org/officeDocument/2006/relationships/image" Target="../media/image12.jpeg"/><Relationship Id="rId14" Type="http://schemas.openxmlformats.org/officeDocument/2006/relationships/image" Target="../media/image13.jpeg"/><Relationship Id="rId1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10960" y="193680"/>
            <a:ext cx="19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12760" y="73512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04840" y="719928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608360" y="2046240"/>
            <a:ext cx="11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7nt ex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6837480" y="6061320"/>
            <a:ext cx="5902200" cy="1914120"/>
            <a:chOff x="6837480" y="6061320"/>
            <a:chExt cx="5902200" cy="1914120"/>
          </a:xfrm>
        </p:grpSpPr>
        <p:sp>
          <p:nvSpPr>
            <p:cNvPr id="46" name=""/>
            <p:cNvSpPr/>
            <p:nvPr/>
          </p:nvSpPr>
          <p:spPr>
            <a:xfrm>
              <a:off x="11835000" y="7259760"/>
              <a:ext cx="904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rot="18088800">
              <a:off x="7856640" y="6575040"/>
              <a:ext cx="86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8079200">
              <a:off x="9975600" y="6553440"/>
              <a:ext cx="90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17-2A&gt;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8068400">
              <a:off x="10365840" y="6472800"/>
              <a:ext cx="1083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18+1G&gt;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flipV="1">
              <a:off x="10850760" y="632916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10425240" y="6325920"/>
              <a:ext cx="4316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flipV="1">
              <a:off x="9993240" y="6327720"/>
              <a:ext cx="43200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V="1">
              <a:off x="9564840" y="6329160"/>
              <a:ext cx="4348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flipV="1">
              <a:off x="9142560" y="632772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V="1">
              <a:off x="8736120" y="6329160"/>
              <a:ext cx="4316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8326440" y="6329160"/>
              <a:ext cx="4352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V="1">
              <a:off x="7910640" y="6325920"/>
              <a:ext cx="4316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8088800">
              <a:off x="8351640" y="6699600"/>
              <a:ext cx="577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rot="18088800">
              <a:off x="8747640" y="6698520"/>
              <a:ext cx="576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rot="18088800">
              <a:off x="9195480" y="6729120"/>
              <a:ext cx="502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rot="18088800">
              <a:off x="9588240" y="6667560"/>
              <a:ext cx="647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rot="18068400">
              <a:off x="10812240" y="6521760"/>
              <a:ext cx="977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18+1G&gt;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rot="17980800">
              <a:off x="11249280" y="6634800"/>
              <a:ext cx="69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N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11209320" y="6325920"/>
              <a:ext cx="4352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1795040" y="7535880"/>
              <a:ext cx="621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8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1323800" y="7664400"/>
              <a:ext cx="50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7286760" y="7470720"/>
              <a:ext cx="506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7282080" y="768996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6837480" y="7356600"/>
              <a:ext cx="52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3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1787120" y="735804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8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6842160" y="7570800"/>
              <a:ext cx="520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2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1325240" y="7477200"/>
              <a:ext cx="506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3" name="" descr=""/>
            <p:cNvPicPr/>
            <p:nvPr/>
          </p:nvPicPr>
          <p:blipFill>
            <a:blip r:embed="rId1"/>
            <a:srcRect l="4402" t="18150" r="10435" b="50769"/>
            <a:stretch/>
          </p:blipFill>
          <p:spPr>
            <a:xfrm>
              <a:off x="7421760" y="7040520"/>
              <a:ext cx="4171680" cy="9349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4" name=""/>
          <p:cNvSpPr/>
          <p:nvPr/>
        </p:nvSpPr>
        <p:spPr>
          <a:xfrm>
            <a:off x="210960" y="193680"/>
            <a:ext cx="19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6675480" y="73980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17440" y="263988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675480" y="263520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8" name=""/>
          <p:cNvGrpSpPr/>
          <p:nvPr/>
        </p:nvGrpSpPr>
        <p:grpSpPr>
          <a:xfrm>
            <a:off x="390600" y="5000760"/>
            <a:ext cx="5068440" cy="2004840"/>
            <a:chOff x="390600" y="5000760"/>
            <a:chExt cx="5068440" cy="2004840"/>
          </a:xfrm>
        </p:grpSpPr>
        <p:sp>
          <p:nvSpPr>
            <p:cNvPr id="79" name=""/>
            <p:cNvSpPr/>
            <p:nvPr/>
          </p:nvSpPr>
          <p:spPr>
            <a:xfrm rot="18088800">
              <a:off x="1314000" y="5505840"/>
              <a:ext cx="86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rot="18079200">
              <a:off x="3391200" y="5406480"/>
              <a:ext cx="1071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4794G&gt;A,E1559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3881160" y="525600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3449520" y="525780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3022560" y="525924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2600280" y="525780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V="1">
              <a:off x="2192040" y="525924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1784160" y="525924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1366560" y="525600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rot="18088800">
              <a:off x="1807200" y="5630040"/>
              <a:ext cx="578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rot="18088800">
              <a:off x="2205000" y="5628600"/>
              <a:ext cx="576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8088800">
              <a:off x="2651400" y="5658840"/>
              <a:ext cx="502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8088800">
              <a:off x="3045960" y="5597640"/>
              <a:ext cx="647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460760" y="6083280"/>
              <a:ext cx="618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5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008240" y="6237360"/>
              <a:ext cx="50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838080" y="6883560"/>
              <a:ext cx="50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838080" y="6208920"/>
              <a:ext cx="50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92040" y="609912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4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90600" y="677376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3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17980800">
              <a:off x="3872160" y="5574600"/>
              <a:ext cx="69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N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465440" y="6261120"/>
              <a:ext cx="99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11nt ex15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0" name=""/>
            <p:cNvGrpSpPr/>
            <p:nvPr/>
          </p:nvGrpSpPr>
          <p:grpSpPr>
            <a:xfrm>
              <a:off x="3865320" y="6281640"/>
              <a:ext cx="652680" cy="89640"/>
              <a:chOff x="3865320" y="6281640"/>
              <a:chExt cx="652680" cy="89640"/>
            </a:xfrm>
          </p:grpSpPr>
          <p:sp>
            <p:nvSpPr>
              <p:cNvPr id="101" name=""/>
              <p:cNvSpPr/>
              <p:nvPr/>
            </p:nvSpPr>
            <p:spPr>
              <a:xfrm>
                <a:off x="3865320" y="6284880"/>
                <a:ext cx="5047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4362840" y="6281640"/>
                <a:ext cx="155160" cy="89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103" name="" descr=""/>
            <p:cNvPicPr/>
            <p:nvPr/>
          </p:nvPicPr>
          <p:blipFill>
            <a:blip r:embed="rId2">
              <a:lum bright="24000"/>
            </a:blip>
            <a:stretch/>
          </p:blipFill>
          <p:spPr>
            <a:xfrm>
              <a:off x="912600" y="5969160"/>
              <a:ext cx="3389040" cy="10364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04" name=""/>
          <p:cNvGrpSpPr/>
          <p:nvPr/>
        </p:nvGrpSpPr>
        <p:grpSpPr>
          <a:xfrm>
            <a:off x="392040" y="7039080"/>
            <a:ext cx="5433840" cy="1847880"/>
            <a:chOff x="392040" y="7039080"/>
            <a:chExt cx="5433840" cy="1847880"/>
          </a:xfrm>
        </p:grpSpPr>
        <p:sp>
          <p:nvSpPr>
            <p:cNvPr id="105" name=""/>
            <p:cNvSpPr/>
            <p:nvPr/>
          </p:nvSpPr>
          <p:spPr>
            <a:xfrm rot="18088800">
              <a:off x="1315800" y="7547400"/>
              <a:ext cx="86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rot="18079200">
              <a:off x="3396240" y="7444800"/>
              <a:ext cx="1071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5193G&gt;C,D1692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V="1">
              <a:off x="3882960" y="729756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flipV="1">
              <a:off x="3450960" y="729936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V="1">
              <a:off x="3024000" y="730080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2601720" y="729936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2193840" y="730080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V="1">
              <a:off x="1785960" y="730080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V="1">
              <a:off x="1368360" y="729756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rot="18088800">
              <a:off x="1809000" y="7671240"/>
              <a:ext cx="578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rot="18088800">
              <a:off x="2206800" y="7670160"/>
              <a:ext cx="576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 rot="18088800">
              <a:off x="2653200" y="7700400"/>
              <a:ext cx="502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rot="18088800">
              <a:off x="3047400" y="7639200"/>
              <a:ext cx="647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462200" y="8258400"/>
              <a:ext cx="619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7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010040" y="838368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839520" y="8677440"/>
              <a:ext cx="505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839520" y="8312400"/>
              <a:ext cx="505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93480" y="820260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4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92040" y="856800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2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 rot="17980800">
              <a:off x="3873600" y="7615800"/>
              <a:ext cx="69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N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457520" y="8056800"/>
              <a:ext cx="136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Ins</a:t>
              </a:r>
              <a:r>
                <a:rPr b="1" lang="de-DE" sz="1000" spc="-1" strike="noStrike">
                  <a:solidFill>
                    <a:srgbClr val="ff3300"/>
                  </a:solidFill>
                  <a:latin typeface="Arial"/>
                </a:rPr>
                <a:t> 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153nt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6" name=""/>
            <p:cNvGrpSpPr/>
            <p:nvPr/>
          </p:nvGrpSpPr>
          <p:grpSpPr>
            <a:xfrm>
              <a:off x="3860640" y="8515440"/>
              <a:ext cx="653400" cy="89640"/>
              <a:chOff x="3860640" y="8515440"/>
              <a:chExt cx="653400" cy="89640"/>
            </a:xfrm>
          </p:grpSpPr>
          <p:sp>
            <p:nvSpPr>
              <p:cNvPr id="127" name=""/>
              <p:cNvSpPr/>
              <p:nvPr/>
            </p:nvSpPr>
            <p:spPr>
              <a:xfrm>
                <a:off x="3860640" y="8518680"/>
                <a:ext cx="5050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4358520" y="8515440"/>
                <a:ext cx="155520" cy="89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9" name=""/>
            <p:cNvSpPr/>
            <p:nvPr/>
          </p:nvSpPr>
          <p:spPr>
            <a:xfrm>
              <a:off x="4468680" y="8464680"/>
              <a:ext cx="619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006800" y="818064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1" name="" descr=""/>
            <p:cNvPicPr/>
            <p:nvPr/>
          </p:nvPicPr>
          <p:blipFill>
            <a:blip r:embed="rId3"/>
            <a:srcRect l="0" t="0" r="0" b="23157"/>
            <a:stretch/>
          </p:blipFill>
          <p:spPr>
            <a:xfrm>
              <a:off x="904680" y="8001000"/>
              <a:ext cx="3384720" cy="885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32" name=""/>
          <p:cNvSpPr/>
          <p:nvPr/>
        </p:nvSpPr>
        <p:spPr>
          <a:xfrm>
            <a:off x="216000" y="515304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6678720" y="433224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6680160" y="622620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5" name=""/>
          <p:cNvGrpSpPr/>
          <p:nvPr/>
        </p:nvGrpSpPr>
        <p:grpSpPr>
          <a:xfrm>
            <a:off x="6838920" y="4054680"/>
            <a:ext cx="6856560" cy="2098440"/>
            <a:chOff x="6838920" y="4054680"/>
            <a:chExt cx="6856560" cy="2098440"/>
          </a:xfrm>
        </p:grpSpPr>
        <p:sp>
          <p:nvSpPr>
            <p:cNvPr id="136" name=""/>
            <p:cNvSpPr/>
            <p:nvPr/>
          </p:nvSpPr>
          <p:spPr>
            <a:xfrm rot="18088800">
              <a:off x="7764840" y="4686120"/>
              <a:ext cx="852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rot="18079200">
              <a:off x="9814320" y="4538520"/>
              <a:ext cx="1185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16+3 G&gt;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rot="18068400">
              <a:off x="10295640" y="4627080"/>
              <a:ext cx="976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16+4 A&gt;G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rot="17980800">
              <a:off x="12027600" y="4753080"/>
              <a:ext cx="69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N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flipV="1">
              <a:off x="12006360" y="443376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V="1">
              <a:off x="11603160" y="4435200"/>
              <a:ext cx="4348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flipV="1">
              <a:off x="11176200" y="443520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V="1">
              <a:off x="10757160" y="443520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flipV="1">
              <a:off x="10329840" y="443232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V="1">
              <a:off x="9898200" y="443376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flipV="1">
              <a:off x="9472680" y="4435200"/>
              <a:ext cx="43200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V="1">
              <a:off x="9048960" y="443376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V="1">
              <a:off x="8640720" y="443520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V="1">
              <a:off x="8234640" y="4435200"/>
              <a:ext cx="4316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V="1">
              <a:off x="7815240" y="443232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rot="18088800">
              <a:off x="8258760" y="4809600"/>
              <a:ext cx="56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rot="18088800">
              <a:off x="8658000" y="4808880"/>
              <a:ext cx="565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rot="18088800">
              <a:off x="8983440" y="4624560"/>
              <a:ext cx="996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rot="18088800">
              <a:off x="9479880" y="4747320"/>
              <a:ext cx="709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rot="18068400">
              <a:off x="10659240" y="4524840"/>
              <a:ext cx="1220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16+4 A&gt;G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rot="18068400">
              <a:off x="11102400" y="4556520"/>
              <a:ext cx="1139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16+5 G&gt;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 rot="18068400">
              <a:off x="11548800" y="4626000"/>
              <a:ext cx="971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16+6T&gt;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12673080" y="5262480"/>
              <a:ext cx="102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Ins 65nt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12676320" y="5454720"/>
              <a:ext cx="619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6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12082680" y="5468760"/>
              <a:ext cx="50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2234960" y="5584680"/>
              <a:ext cx="50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 flipV="1">
              <a:off x="12576960" y="5380920"/>
              <a:ext cx="155880" cy="89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7288200" y="5745240"/>
              <a:ext cx="50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7288200" y="5427720"/>
              <a:ext cx="50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6840720" y="5318280"/>
              <a:ext cx="52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6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6838920" y="563724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4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67" name="" descr=""/>
            <p:cNvPicPr/>
            <p:nvPr/>
          </p:nvPicPr>
          <p:blipFill>
            <a:blip r:embed="rId4">
              <a:lum bright="24000"/>
            </a:blip>
            <a:stretch/>
          </p:blipFill>
          <p:spPr>
            <a:xfrm>
              <a:off x="7359840" y="5148360"/>
              <a:ext cx="5116320" cy="10047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68" name=""/>
          <p:cNvSpPr/>
          <p:nvPr/>
        </p:nvSpPr>
        <p:spPr>
          <a:xfrm>
            <a:off x="4608360" y="2046240"/>
            <a:ext cx="11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7nt ex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9" name=""/>
          <p:cNvGrpSpPr/>
          <p:nvPr/>
        </p:nvGrpSpPr>
        <p:grpSpPr>
          <a:xfrm>
            <a:off x="385920" y="664560"/>
            <a:ext cx="4866840" cy="1911960"/>
            <a:chOff x="385920" y="664560"/>
            <a:chExt cx="4866840" cy="1911960"/>
          </a:xfrm>
        </p:grpSpPr>
        <p:sp>
          <p:nvSpPr>
            <p:cNvPr id="170" name=""/>
            <p:cNvSpPr/>
            <p:nvPr/>
          </p:nvSpPr>
          <p:spPr>
            <a:xfrm rot="18088800">
              <a:off x="1316160" y="1036080"/>
              <a:ext cx="992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rot="18079200">
              <a:off x="3471480" y="1076760"/>
              <a:ext cx="885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1G</a:t>
              </a: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&gt;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flipV="1">
              <a:off x="3916440" y="84132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flipV="1">
              <a:off x="3484440" y="84276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 flipV="1">
              <a:off x="3056040" y="844560"/>
              <a:ext cx="43452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flipV="1">
              <a:off x="2633760" y="842760"/>
              <a:ext cx="43272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flipV="1">
              <a:off x="2225520" y="84456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flipV="1">
              <a:off x="1817640" y="84456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flipV="1">
              <a:off x="1400040" y="84132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rot="18088800">
              <a:off x="1809720" y="1159920"/>
              <a:ext cx="70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rot="18088800">
              <a:off x="2157120" y="1067040"/>
              <a:ext cx="920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rot="18088800">
              <a:off x="2638080" y="1158840"/>
              <a:ext cx="704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rot="18088800">
              <a:off x="3067920" y="1159200"/>
              <a:ext cx="704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4643280" y="1844640"/>
              <a:ext cx="609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3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4176720" y="1974960"/>
              <a:ext cx="50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5" name=""/>
            <p:cNvGrpSpPr/>
            <p:nvPr/>
          </p:nvGrpSpPr>
          <p:grpSpPr>
            <a:xfrm>
              <a:off x="4024440" y="2036520"/>
              <a:ext cx="652320" cy="89640"/>
              <a:chOff x="4024440" y="2036520"/>
              <a:chExt cx="652320" cy="89640"/>
            </a:xfrm>
          </p:grpSpPr>
          <p:sp>
            <p:nvSpPr>
              <p:cNvPr id="186" name=""/>
              <p:cNvSpPr/>
              <p:nvPr/>
            </p:nvSpPr>
            <p:spPr>
              <a:xfrm>
                <a:off x="4024440" y="2040120"/>
                <a:ext cx="504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4521600" y="2036520"/>
                <a:ext cx="155160" cy="89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8" name=""/>
            <p:cNvSpPr/>
            <p:nvPr/>
          </p:nvSpPr>
          <p:spPr>
            <a:xfrm>
              <a:off x="833400" y="2468520"/>
              <a:ext cx="50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833400" y="1652760"/>
              <a:ext cx="50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387360" y="154332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2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385920" y="236088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1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rot="17980800">
              <a:off x="3957840" y="1150560"/>
              <a:ext cx="694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N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93" name="" descr=""/>
            <p:cNvPicPr/>
            <p:nvPr/>
          </p:nvPicPr>
          <p:blipFill>
            <a:blip r:embed="rId5">
              <a:lum bright="6000"/>
            </a:blip>
            <a:stretch/>
          </p:blipFill>
          <p:spPr>
            <a:xfrm>
              <a:off x="911160" y="1555920"/>
              <a:ext cx="3381120" cy="100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4" name=""/>
            <p:cNvSpPr/>
            <p:nvPr/>
          </p:nvSpPr>
          <p:spPr>
            <a:xfrm>
              <a:off x="3419280" y="1725840"/>
              <a:ext cx="236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2000" spc="-1" strike="noStrike">
                  <a:solidFill>
                    <a:srgbClr val="ff0000"/>
                  </a:solidFill>
                  <a:latin typeface="Arial"/>
                </a:rPr>
                <a:t>*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5" name=""/>
          <p:cNvGrpSpPr/>
          <p:nvPr/>
        </p:nvGrpSpPr>
        <p:grpSpPr>
          <a:xfrm>
            <a:off x="6840360" y="664920"/>
            <a:ext cx="5586120" cy="1818000"/>
            <a:chOff x="6840360" y="664920"/>
            <a:chExt cx="5586120" cy="1818000"/>
          </a:xfrm>
        </p:grpSpPr>
        <p:grpSp>
          <p:nvGrpSpPr>
            <p:cNvPr id="196" name=""/>
            <p:cNvGrpSpPr/>
            <p:nvPr/>
          </p:nvGrpSpPr>
          <p:grpSpPr>
            <a:xfrm>
              <a:off x="6840360" y="664920"/>
              <a:ext cx="5586120" cy="1818000"/>
              <a:chOff x="6840360" y="664920"/>
              <a:chExt cx="5586120" cy="1818000"/>
            </a:xfrm>
          </p:grpSpPr>
          <p:sp>
            <p:nvSpPr>
              <p:cNvPr id="197" name=""/>
              <p:cNvSpPr/>
              <p:nvPr/>
            </p:nvSpPr>
            <p:spPr>
              <a:xfrm>
                <a:off x="11366280" y="1903680"/>
                <a:ext cx="50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 rot="18088800">
                <a:off x="7765560" y="1081080"/>
                <a:ext cx="863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 rot="18079200">
                <a:off x="9881280" y="1060920"/>
                <a:ext cx="901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sz="800" spc="-1" strike="noStrike">
                    <a:solidFill>
                      <a:srgbClr val="000000"/>
                    </a:solidFill>
                    <a:latin typeface="Arial"/>
                  </a:rPr>
                  <a:t>IVS9-2A&gt;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 rot="18068400">
                <a:off x="10317600" y="1069200"/>
                <a:ext cx="890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sz="800" spc="-1" strike="noStrike">
                    <a:solidFill>
                      <a:srgbClr val="000000"/>
                    </a:solidFill>
                    <a:latin typeface="Arial"/>
                  </a:rPr>
                  <a:t>IVS9-34T&gt;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 flipV="1">
                <a:off x="10758240" y="834840"/>
                <a:ext cx="43344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 flipV="1">
                <a:off x="10331280" y="831960"/>
                <a:ext cx="433080" cy="719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 flipV="1">
                <a:off x="9899280" y="833400"/>
                <a:ext cx="433440" cy="719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 flipV="1">
                <a:off x="9473760" y="834840"/>
                <a:ext cx="43200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 flipV="1">
                <a:off x="9050040" y="833400"/>
                <a:ext cx="433440" cy="719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 flipV="1">
                <a:off x="8642160" y="834840"/>
                <a:ext cx="43344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 flipV="1">
                <a:off x="8235720" y="834840"/>
                <a:ext cx="43164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 flipV="1">
                <a:off x="7816680" y="831960"/>
                <a:ext cx="433080" cy="719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 rot="18088800">
                <a:off x="8257320" y="1204560"/>
                <a:ext cx="577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 rot="18088800">
                <a:off x="8655480" y="1204560"/>
                <a:ext cx="576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3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 rot="18088800">
                <a:off x="9101160" y="1234080"/>
                <a:ext cx="503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4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 rot="18088800">
                <a:off x="9495720" y="1173600"/>
                <a:ext cx="648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5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 rot="18068400">
                <a:off x="10717920" y="1031400"/>
                <a:ext cx="977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sz="800" spc="-1" strike="noStrike">
                    <a:solidFill>
                      <a:srgbClr val="000000"/>
                    </a:solidFill>
                    <a:latin typeface="Arial"/>
                  </a:rPr>
                  <a:t>787A&gt;G,K223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11804400" y="1776600"/>
                <a:ext cx="609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</a:rPr>
                  <a:t>ex10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11807640" y="2070360"/>
                <a:ext cx="618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</a:t>
                </a: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</a:rPr>
                  <a:t>ex10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11366280" y="2200320"/>
                <a:ext cx="50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7289640" y="2202120"/>
                <a:ext cx="5029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7289640" y="1865520"/>
                <a:ext cx="5029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6841800" y="1756080"/>
                <a:ext cx="523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300 bp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6840360" y="2094120"/>
                <a:ext cx="522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200 bp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221" name="" descr=""/>
              <p:cNvPicPr/>
              <p:nvPr/>
            </p:nvPicPr>
            <p:blipFill>
              <a:blip r:embed="rId6">
                <a:lum contrast="30000"/>
              </a:blip>
              <a:srcRect l="9997" t="22377" r="31450" b="59788"/>
              <a:stretch/>
            </p:blipFill>
            <p:spPr>
              <a:xfrm>
                <a:off x="7372080" y="1552680"/>
                <a:ext cx="4165560" cy="930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22" name=""/>
              <p:cNvSpPr/>
              <p:nvPr/>
            </p:nvSpPr>
            <p:spPr>
              <a:xfrm rot="17980800">
                <a:off x="11158560" y="1139400"/>
                <a:ext cx="693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NT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 flipV="1">
                <a:off x="11118600" y="831960"/>
                <a:ext cx="431640" cy="719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4" name=""/>
            <p:cNvSpPr/>
            <p:nvPr/>
          </p:nvSpPr>
          <p:spPr>
            <a:xfrm>
              <a:off x="9845280" y="1919520"/>
              <a:ext cx="2368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2000" spc="-1" strike="noStrike">
                  <a:solidFill>
                    <a:srgbClr val="ff0000"/>
                  </a:solidFill>
                  <a:latin typeface="Arial"/>
                </a:rPr>
                <a:t>*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5" name=""/>
          <p:cNvGrpSpPr/>
          <p:nvPr/>
        </p:nvGrpSpPr>
        <p:grpSpPr>
          <a:xfrm>
            <a:off x="390600" y="2492280"/>
            <a:ext cx="5803920" cy="2517840"/>
            <a:chOff x="390600" y="2492280"/>
            <a:chExt cx="5803920" cy="2517840"/>
          </a:xfrm>
        </p:grpSpPr>
        <p:sp>
          <p:nvSpPr>
            <p:cNvPr id="226" name=""/>
            <p:cNvSpPr/>
            <p:nvPr/>
          </p:nvSpPr>
          <p:spPr>
            <a:xfrm>
              <a:off x="5008680" y="3468960"/>
              <a:ext cx="609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4542120" y="359892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5008680" y="4572000"/>
              <a:ext cx="609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4542120" y="470232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 rot="18088800">
              <a:off x="1805040" y="2998800"/>
              <a:ext cx="86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 rot="18079200">
              <a:off x="3883680" y="2898000"/>
              <a:ext cx="1071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IVS11+3A&gt;G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 flipV="1">
              <a:off x="4372200" y="274968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 flipV="1">
              <a:off x="3940560" y="275112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 flipV="1">
              <a:off x="3513240" y="275256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 flipV="1">
              <a:off x="3090960" y="275112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 flipV="1">
              <a:off x="2683080" y="275256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 flipV="1">
              <a:off x="2275200" y="275256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 flipV="1">
              <a:off x="1857600" y="274968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 rot="18088800">
              <a:off x="2298600" y="3123000"/>
              <a:ext cx="577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rot="18088800">
              <a:off x="2696400" y="3122280"/>
              <a:ext cx="576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rot="18088800">
              <a:off x="3142440" y="3152520"/>
              <a:ext cx="50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rot="18088800">
              <a:off x="3536640" y="3091320"/>
              <a:ext cx="648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rot="17980800">
              <a:off x="4362840" y="3067920"/>
              <a:ext cx="69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N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838440" y="477864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838440" y="417852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392400" y="406908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5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390600" y="467064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1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841680" y="358164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395640" y="346716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3.5 k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5008680" y="4351320"/>
              <a:ext cx="118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3309 nt ex1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4542120" y="448164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52" name="" descr=""/>
            <p:cNvPicPr/>
            <p:nvPr/>
          </p:nvPicPr>
          <p:blipFill>
            <a:blip r:embed="rId7"/>
            <a:srcRect l="2206" t="21614" r="53669" b="54906"/>
            <a:stretch/>
          </p:blipFill>
          <p:spPr>
            <a:xfrm>
              <a:off x="911520" y="3465720"/>
              <a:ext cx="3908520" cy="1544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3" name=""/>
            <p:cNvSpPr/>
            <p:nvPr/>
          </p:nvSpPr>
          <p:spPr>
            <a:xfrm>
              <a:off x="5008680" y="3468960"/>
              <a:ext cx="609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4542120" y="359892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5008680" y="4572000"/>
              <a:ext cx="609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4542120" y="470232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 rot="18088800">
              <a:off x="1805040" y="2998800"/>
              <a:ext cx="86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 rot="18079200">
              <a:off x="3883680" y="2898000"/>
              <a:ext cx="1071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IVS11+3A&gt;G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 flipV="1">
              <a:off x="4372200" y="274968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 flipV="1">
              <a:off x="3940560" y="275112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 flipV="1">
              <a:off x="3513240" y="275256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 flipV="1">
              <a:off x="3090960" y="275112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 flipV="1">
              <a:off x="2683080" y="275256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 flipV="1">
              <a:off x="2275200" y="275256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 flipV="1">
              <a:off x="1857600" y="274968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 rot="18088800">
              <a:off x="2298600" y="3123000"/>
              <a:ext cx="577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 rot="18088800">
              <a:off x="2696400" y="3122280"/>
              <a:ext cx="576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 rot="18088800">
              <a:off x="3142440" y="3152520"/>
              <a:ext cx="50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 rot="18088800">
              <a:off x="3536640" y="3091320"/>
              <a:ext cx="648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 rot="17980800">
              <a:off x="4362840" y="3067920"/>
              <a:ext cx="69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N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838440" y="477864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838440" y="417852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392400" y="406908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5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390600" y="467064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1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841680" y="358164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395640" y="346716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3.5 k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5008680" y="4351320"/>
              <a:ext cx="118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3309 nt ex1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4542120" y="448164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79" name="" descr=""/>
            <p:cNvPicPr/>
            <p:nvPr/>
          </p:nvPicPr>
          <p:blipFill>
            <a:blip r:embed="rId8"/>
            <a:srcRect l="2206" t="21614" r="53669" b="54906"/>
            <a:stretch/>
          </p:blipFill>
          <p:spPr>
            <a:xfrm>
              <a:off x="911520" y="3465720"/>
              <a:ext cx="3908520" cy="15444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80" name=""/>
          <p:cNvGrpSpPr/>
          <p:nvPr/>
        </p:nvGrpSpPr>
        <p:grpSpPr>
          <a:xfrm>
            <a:off x="6840360" y="7994880"/>
            <a:ext cx="5954760" cy="2257200"/>
            <a:chOff x="6840360" y="7994880"/>
            <a:chExt cx="5954760" cy="2257200"/>
          </a:xfrm>
        </p:grpSpPr>
        <p:sp>
          <p:nvSpPr>
            <p:cNvPr id="281" name=""/>
            <p:cNvSpPr/>
            <p:nvPr/>
          </p:nvSpPr>
          <p:spPr>
            <a:xfrm>
              <a:off x="11337840" y="9401040"/>
              <a:ext cx="50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 rot="18088800">
              <a:off x="7765560" y="8413560"/>
              <a:ext cx="86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 rot="18079200">
              <a:off x="9883080" y="8391600"/>
              <a:ext cx="90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20-1G&gt;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 rot="18068400">
              <a:off x="10319040" y="8400600"/>
              <a:ext cx="890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20-14C&gt;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 flipV="1">
              <a:off x="10758240" y="816768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 flipV="1">
              <a:off x="10331280" y="816444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 flipV="1">
              <a:off x="9899640" y="816588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 flipV="1">
              <a:off x="9474120" y="8167680"/>
              <a:ext cx="4316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 flipV="1">
              <a:off x="9050040" y="816588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 flipV="1">
              <a:off x="8642160" y="816768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 flipV="1">
              <a:off x="8235720" y="8167680"/>
              <a:ext cx="43200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 flipV="1">
              <a:off x="7816680" y="816444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 rot="18088800">
              <a:off x="8257680" y="8537400"/>
              <a:ext cx="577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 rot="18088800">
              <a:off x="8655480" y="8537040"/>
              <a:ext cx="576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 rot="18088800">
              <a:off x="9101520" y="8566920"/>
              <a:ext cx="50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 rot="18088800">
              <a:off x="9495720" y="8506080"/>
              <a:ext cx="648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 rot="18068400">
              <a:off x="10718280" y="8361360"/>
              <a:ext cx="977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21+13G&gt;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11812320" y="9798120"/>
              <a:ext cx="619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2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11339280" y="992808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7289640" y="9575640"/>
              <a:ext cx="50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7289640" y="8956800"/>
              <a:ext cx="50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6841800" y="8847000"/>
              <a:ext cx="524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2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6840360" y="946800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1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 rot="17980800">
              <a:off x="11158560" y="8471520"/>
              <a:ext cx="69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N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 flipV="1">
              <a:off x="11118600" y="8164440"/>
              <a:ext cx="43200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11802960" y="9266040"/>
              <a:ext cx="552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2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11801160" y="9462960"/>
              <a:ext cx="99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8nt ex2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08" name=""/>
            <p:cNvGrpSpPr/>
            <p:nvPr/>
          </p:nvGrpSpPr>
          <p:grpSpPr>
            <a:xfrm>
              <a:off x="11191680" y="9483480"/>
              <a:ext cx="653400" cy="89640"/>
              <a:chOff x="11191680" y="9483480"/>
              <a:chExt cx="653400" cy="89640"/>
            </a:xfrm>
          </p:grpSpPr>
          <p:sp>
            <p:nvSpPr>
              <p:cNvPr id="309" name=""/>
              <p:cNvSpPr/>
              <p:nvPr/>
            </p:nvSpPr>
            <p:spPr>
              <a:xfrm>
                <a:off x="11191680" y="9486720"/>
                <a:ext cx="5050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11689560" y="9483480"/>
                <a:ext cx="155520" cy="89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311" name="" descr=""/>
            <p:cNvPicPr/>
            <p:nvPr/>
          </p:nvPicPr>
          <p:blipFill>
            <a:blip r:embed="rId9"/>
            <a:stretch/>
          </p:blipFill>
          <p:spPr>
            <a:xfrm>
              <a:off x="7360920" y="8880480"/>
              <a:ext cx="4176720" cy="13716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312" name=""/>
          <p:cNvGrpSpPr/>
          <p:nvPr/>
        </p:nvGrpSpPr>
        <p:grpSpPr>
          <a:xfrm>
            <a:off x="6851520" y="12071520"/>
            <a:ext cx="4813560" cy="1876320"/>
            <a:chOff x="6851520" y="12071520"/>
            <a:chExt cx="4813560" cy="1876320"/>
          </a:xfrm>
        </p:grpSpPr>
        <p:sp>
          <p:nvSpPr>
            <p:cNvPr id="313" name=""/>
            <p:cNvSpPr/>
            <p:nvPr/>
          </p:nvSpPr>
          <p:spPr>
            <a:xfrm>
              <a:off x="11045880" y="13255560"/>
              <a:ext cx="619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23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11042640" y="13500000"/>
              <a:ext cx="619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 rot="18088800">
              <a:off x="7775280" y="12577680"/>
              <a:ext cx="86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 rot="18079200">
              <a:off x="9854280" y="12477240"/>
              <a:ext cx="1071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5527G&gt;C,G1803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 flipV="1">
              <a:off x="10344240" y="12328560"/>
              <a:ext cx="4316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 flipV="1">
              <a:off x="9912240" y="12330000"/>
              <a:ext cx="43200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 flipV="1">
              <a:off x="9483840" y="12331800"/>
              <a:ext cx="4348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 flipV="1">
              <a:off x="9061560" y="12330000"/>
              <a:ext cx="4334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 flipV="1">
              <a:off x="8655120" y="12331800"/>
              <a:ext cx="4316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 flipV="1">
              <a:off x="8245440" y="12331800"/>
              <a:ext cx="4348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 flipV="1">
              <a:off x="7829640" y="12328560"/>
              <a:ext cx="4316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 rot="18088800">
              <a:off x="8270280" y="12699720"/>
              <a:ext cx="577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 rot="18088800">
              <a:off x="8666640" y="12701160"/>
              <a:ext cx="576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 rot="18088800">
              <a:off x="9114480" y="12729600"/>
              <a:ext cx="50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 rot="18088800">
              <a:off x="9507240" y="12670200"/>
              <a:ext cx="648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10594800" y="13409640"/>
              <a:ext cx="50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7299360" y="1369368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7299360" y="1335240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6853320" y="1324296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2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6851520" y="1358424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1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 rot="17980800">
              <a:off x="10333440" y="12646800"/>
              <a:ext cx="69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N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10601280" y="13630320"/>
              <a:ext cx="50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35" name="" descr=""/>
            <p:cNvPicPr/>
            <p:nvPr/>
          </p:nvPicPr>
          <p:blipFill>
            <a:blip r:embed="rId10"/>
            <a:srcRect l="0" t="12211" r="0" b="0"/>
            <a:stretch/>
          </p:blipFill>
          <p:spPr>
            <a:xfrm>
              <a:off x="7361280" y="13044600"/>
              <a:ext cx="3470400" cy="9032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336" name=""/>
          <p:cNvSpPr/>
          <p:nvPr/>
        </p:nvSpPr>
        <p:spPr>
          <a:xfrm>
            <a:off x="6670800" y="10352160"/>
            <a:ext cx="460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7" name=""/>
          <p:cNvGrpSpPr/>
          <p:nvPr/>
        </p:nvGrpSpPr>
        <p:grpSpPr>
          <a:xfrm>
            <a:off x="393840" y="11270160"/>
            <a:ext cx="6289200" cy="2046960"/>
            <a:chOff x="393840" y="11270160"/>
            <a:chExt cx="6289200" cy="2046960"/>
          </a:xfrm>
        </p:grpSpPr>
        <p:sp>
          <p:nvSpPr>
            <p:cNvPr id="338" name=""/>
            <p:cNvSpPr/>
            <p:nvPr/>
          </p:nvSpPr>
          <p:spPr>
            <a:xfrm rot="18088800">
              <a:off x="1319400" y="11901240"/>
              <a:ext cx="852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 rot="18079200">
              <a:off x="3367080" y="11754720"/>
              <a:ext cx="1185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21-1G&gt;T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 rot="18068400">
              <a:off x="3848400" y="11843640"/>
              <a:ext cx="976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21-1G&gt;T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 rot="17980800">
              <a:off x="5581800" y="11968560"/>
              <a:ext cx="69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N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 flipV="1">
              <a:off x="5560920" y="1164852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 flipV="1">
              <a:off x="5157720" y="11650320"/>
              <a:ext cx="43452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 flipV="1">
              <a:off x="4730760" y="1165032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 flipV="1">
              <a:off x="4311720" y="11650320"/>
              <a:ext cx="43272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 flipV="1">
              <a:off x="3884400" y="1164708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 flipV="1">
              <a:off x="3452760" y="1164852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 flipV="1">
              <a:off x="3027240" y="11650320"/>
              <a:ext cx="4316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 flipV="1">
              <a:off x="2603520" y="11648520"/>
              <a:ext cx="43308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 flipV="1">
              <a:off x="2195280" y="1165032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 flipV="1">
              <a:off x="1789200" y="11650320"/>
              <a:ext cx="4312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 flipV="1">
              <a:off x="1369800" y="11647080"/>
              <a:ext cx="4330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 rot="18088800">
              <a:off x="1813320" y="12024360"/>
              <a:ext cx="567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 rot="18088800">
              <a:off x="2212560" y="12023640"/>
              <a:ext cx="565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 rot="18088800">
              <a:off x="2538000" y="11839320"/>
              <a:ext cx="996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 rot="18088800">
              <a:off x="3034440" y="11962080"/>
              <a:ext cx="709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 rot="18068400">
              <a:off x="4213440" y="11740320"/>
              <a:ext cx="1220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22+2delT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 rot="18068400">
              <a:off x="4655520" y="11773080"/>
              <a:ext cx="1139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22+2delT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 rot="18068400">
              <a:off x="5101560" y="11842560"/>
              <a:ext cx="971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22+2delT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6113520" y="12534480"/>
              <a:ext cx="475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22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6116400" y="12958560"/>
              <a:ext cx="56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22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5675400" y="13088520"/>
              <a:ext cx="502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842760" y="12788640"/>
              <a:ext cx="502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842760" y="12423600"/>
              <a:ext cx="502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395280" y="12313800"/>
              <a:ext cx="523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2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393840" y="1268064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1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67" name="" descr=""/>
            <p:cNvPicPr/>
            <p:nvPr/>
          </p:nvPicPr>
          <p:blipFill>
            <a:blip r:embed="rId11"/>
            <a:stretch/>
          </p:blipFill>
          <p:spPr>
            <a:xfrm>
              <a:off x="914400" y="12363120"/>
              <a:ext cx="5040000" cy="95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68" name=""/>
            <p:cNvSpPr/>
            <p:nvPr/>
          </p:nvSpPr>
          <p:spPr>
            <a:xfrm>
              <a:off x="5673600" y="12679200"/>
              <a:ext cx="502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3387600" y="12685320"/>
              <a:ext cx="236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2000" spc="-1" strike="noStrike">
                  <a:solidFill>
                    <a:srgbClr val="ff0000"/>
                  </a:solidFill>
                  <a:latin typeface="Arial"/>
                </a:rPr>
                <a:t>*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3822480" y="12683880"/>
              <a:ext cx="236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2000" spc="-1" strike="noStrike">
                  <a:solidFill>
                    <a:srgbClr val="ff0000"/>
                  </a:solidFill>
                  <a:latin typeface="Arial"/>
                </a:rPr>
                <a:t>*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4252680" y="12674160"/>
              <a:ext cx="2365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2000" spc="-1" strike="noStrike">
                  <a:solidFill>
                    <a:srgbClr val="ff0000"/>
                  </a:solidFill>
                  <a:latin typeface="Arial"/>
                </a:rPr>
                <a:t>*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4692600" y="12652200"/>
              <a:ext cx="236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2000" spc="-1" strike="noStrike">
                  <a:solidFill>
                    <a:srgbClr val="ff0000"/>
                  </a:solidFill>
                  <a:latin typeface="Arial"/>
                </a:rPr>
                <a:t>*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5100480" y="12636360"/>
              <a:ext cx="236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2000" spc="-1" strike="noStrike">
                  <a:solidFill>
                    <a:srgbClr val="ff0000"/>
                  </a:solidFill>
                  <a:latin typeface="Arial"/>
                </a:rPr>
                <a:t>*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4" name=""/>
          <p:cNvGrpSpPr/>
          <p:nvPr/>
        </p:nvGrpSpPr>
        <p:grpSpPr>
          <a:xfrm>
            <a:off x="6832440" y="10073160"/>
            <a:ext cx="5203800" cy="1944000"/>
            <a:chOff x="6832440" y="10073160"/>
            <a:chExt cx="5203800" cy="1944000"/>
          </a:xfrm>
        </p:grpSpPr>
        <p:sp>
          <p:nvSpPr>
            <p:cNvPr id="375" name=""/>
            <p:cNvSpPr/>
            <p:nvPr/>
          </p:nvSpPr>
          <p:spPr>
            <a:xfrm rot="18068400">
              <a:off x="10330200" y="10645200"/>
              <a:ext cx="976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IVS22+4A&gt;G</a:t>
              </a:r>
              <a:r>
                <a:rPr b="0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76" name=""/>
            <p:cNvGrpSpPr/>
            <p:nvPr/>
          </p:nvGrpSpPr>
          <p:grpSpPr>
            <a:xfrm>
              <a:off x="6832440" y="10073160"/>
              <a:ext cx="5203800" cy="1944000"/>
              <a:chOff x="6832440" y="10073160"/>
              <a:chExt cx="5203800" cy="1944000"/>
            </a:xfrm>
          </p:grpSpPr>
          <p:sp>
            <p:nvSpPr>
              <p:cNvPr id="377" name=""/>
              <p:cNvSpPr/>
              <p:nvPr/>
            </p:nvSpPr>
            <p:spPr>
              <a:xfrm rot="18068400">
                <a:off x="9820440" y="10543320"/>
                <a:ext cx="1220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sz="800" spc="-1" strike="noStrike">
                    <a:solidFill>
                      <a:srgbClr val="000000"/>
                    </a:solidFill>
                    <a:latin typeface="Arial"/>
                  </a:rPr>
                  <a:t>IVS22+3A&gt;T</a:t>
                </a:r>
                <a:r>
                  <a:rPr b="0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 rot="18088800">
                <a:off x="7765920" y="10704240"/>
                <a:ext cx="852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 rot="17980800">
                <a:off x="10774440" y="10771560"/>
                <a:ext cx="693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NT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 flipV="1">
                <a:off x="10758240" y="10453320"/>
                <a:ext cx="43344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 flipV="1">
                <a:off x="10331280" y="10450080"/>
                <a:ext cx="43308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 flipV="1">
                <a:off x="9899280" y="10451880"/>
                <a:ext cx="433440" cy="719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 flipV="1">
                <a:off x="9473760" y="10453320"/>
                <a:ext cx="43200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 flipV="1">
                <a:off x="9050040" y="10451880"/>
                <a:ext cx="433440" cy="719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 flipV="1">
                <a:off x="8642160" y="10453320"/>
                <a:ext cx="43344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 flipV="1">
                <a:off x="8235720" y="10453320"/>
                <a:ext cx="43164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 flipV="1">
                <a:off x="7816680" y="10450080"/>
                <a:ext cx="43308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 rot="18088800">
                <a:off x="8259840" y="10827720"/>
                <a:ext cx="566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 rot="18088800">
                <a:off x="8659080" y="10827000"/>
                <a:ext cx="565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3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 rot="18088800">
                <a:off x="8984160" y="10642680"/>
                <a:ext cx="997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4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 rot="18088800">
                <a:off x="9480960" y="10764720"/>
                <a:ext cx="709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5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7281720" y="11658600"/>
                <a:ext cx="5029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>
                <a:off x="7284600" y="11282040"/>
                <a:ext cx="50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6837120" y="11172600"/>
                <a:ext cx="523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200 bp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>
                <a:off x="6832440" y="11550600"/>
                <a:ext cx="522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100 bp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396" name="" descr=""/>
              <p:cNvPicPr/>
              <p:nvPr/>
            </p:nvPicPr>
            <p:blipFill>
              <a:blip r:embed="rId12"/>
              <a:srcRect l="725" t="40982" r="0" b="0"/>
              <a:stretch/>
            </p:blipFill>
            <p:spPr>
              <a:xfrm>
                <a:off x="7351560" y="11166120"/>
                <a:ext cx="3789360" cy="851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97" name=""/>
              <p:cNvSpPr/>
              <p:nvPr/>
            </p:nvSpPr>
            <p:spPr>
              <a:xfrm>
                <a:off x="11410560" y="11275920"/>
                <a:ext cx="552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</a:rPr>
                  <a:t>ex22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11417040" y="11598120"/>
                <a:ext cx="619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</a:t>
                </a: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</a:rPr>
                  <a:t>ex22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>
                <a:off x="10975680" y="11728440"/>
                <a:ext cx="50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>
                <a:off x="10971000" y="11420280"/>
                <a:ext cx="503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401" name=""/>
          <p:cNvGrpSpPr/>
          <p:nvPr/>
        </p:nvGrpSpPr>
        <p:grpSpPr>
          <a:xfrm>
            <a:off x="392040" y="8765640"/>
            <a:ext cx="6086520" cy="2139120"/>
            <a:chOff x="392040" y="8765640"/>
            <a:chExt cx="6086520" cy="2139120"/>
          </a:xfrm>
        </p:grpSpPr>
        <p:sp>
          <p:nvSpPr>
            <p:cNvPr id="402" name=""/>
            <p:cNvSpPr/>
            <p:nvPr/>
          </p:nvSpPr>
          <p:spPr>
            <a:xfrm>
              <a:off x="5038560" y="10037880"/>
              <a:ext cx="1436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20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5041800" y="10204560"/>
              <a:ext cx="1436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13nt ex20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04" name=""/>
            <p:cNvGrpSpPr/>
            <p:nvPr/>
          </p:nvGrpSpPr>
          <p:grpSpPr>
            <a:xfrm>
              <a:off x="392040" y="8765640"/>
              <a:ext cx="5266800" cy="2139120"/>
              <a:chOff x="392040" y="8765640"/>
              <a:chExt cx="5266800" cy="2139120"/>
            </a:xfrm>
          </p:grpSpPr>
          <p:sp>
            <p:nvSpPr>
              <p:cNvPr id="405" name=""/>
              <p:cNvSpPr/>
              <p:nvPr/>
            </p:nvSpPr>
            <p:spPr>
              <a:xfrm rot="18079200">
                <a:off x="3414240" y="9267120"/>
                <a:ext cx="129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sz="800" spc="-1" strike="noStrike">
                    <a:solidFill>
                      <a:srgbClr val="000000"/>
                    </a:solidFill>
                    <a:latin typeface="Arial"/>
                  </a:rPr>
                  <a:t>IVS19-1G&gt;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 rot="18068400">
                <a:off x="3840120" y="9270000"/>
                <a:ext cx="1293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sz="800" spc="-1" strike="noStrike">
                    <a:solidFill>
                      <a:srgbClr val="000000"/>
                    </a:solidFill>
                    <a:latin typeface="Arial"/>
                  </a:rPr>
                  <a:t>IVS20+15C&gt;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07" name=""/>
              <p:cNvGrpSpPr/>
              <p:nvPr/>
            </p:nvGrpSpPr>
            <p:grpSpPr>
              <a:xfrm>
                <a:off x="4420800" y="10232640"/>
                <a:ext cx="652680" cy="89640"/>
                <a:chOff x="4420800" y="10232640"/>
                <a:chExt cx="652680" cy="89640"/>
              </a:xfrm>
            </p:grpSpPr>
            <p:sp>
              <p:nvSpPr>
                <p:cNvPr id="408" name=""/>
                <p:cNvSpPr/>
                <p:nvPr/>
              </p:nvSpPr>
              <p:spPr>
                <a:xfrm>
                  <a:off x="4420800" y="10236240"/>
                  <a:ext cx="50472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9" name=""/>
                <p:cNvSpPr/>
                <p:nvPr/>
              </p:nvSpPr>
              <p:spPr>
                <a:xfrm>
                  <a:off x="4918320" y="10232640"/>
                  <a:ext cx="155160" cy="896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10" name=""/>
              <p:cNvSpPr/>
              <p:nvPr/>
            </p:nvSpPr>
            <p:spPr>
              <a:xfrm rot="18088800">
                <a:off x="1421640" y="9522000"/>
                <a:ext cx="714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 flipV="1">
                <a:off x="4373280" y="9208800"/>
                <a:ext cx="43128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 flipV="1">
                <a:off x="3944520" y="9205560"/>
                <a:ext cx="43452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 flipV="1">
                <a:off x="3512880" y="9207360"/>
                <a:ext cx="434520" cy="719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 flipV="1">
                <a:off x="3085560" y="9208800"/>
                <a:ext cx="43308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 flipV="1">
                <a:off x="2665080" y="9207360"/>
                <a:ext cx="431280" cy="719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 flipV="1">
                <a:off x="2255400" y="9208800"/>
                <a:ext cx="43452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 flipV="1">
                <a:off x="1847520" y="9208800"/>
                <a:ext cx="43308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 flipV="1">
                <a:off x="1429920" y="9205560"/>
                <a:ext cx="434520" cy="718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 rot="18088800">
                <a:off x="1900080" y="9613080"/>
                <a:ext cx="500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 rot="18088800">
                <a:off x="2297880" y="9612360"/>
                <a:ext cx="498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3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 rot="18088800">
                <a:off x="2726640" y="9612000"/>
                <a:ext cx="498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4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 rot="18088800">
                <a:off x="3155040" y="9612360"/>
                <a:ext cx="498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C (5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 rot="17980800">
                <a:off x="4376520" y="9530640"/>
                <a:ext cx="693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NT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>
                <a:off x="4570200" y="10177560"/>
                <a:ext cx="5025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>
                <a:off x="5040000" y="10658520"/>
                <a:ext cx="618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</a:t>
                </a: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</a:rPr>
                  <a:t>ex20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839520" y="10625040"/>
                <a:ext cx="504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>
                <a:off x="839520" y="9997920"/>
                <a:ext cx="504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394920" y="9888480"/>
                <a:ext cx="520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200 bp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>
                <a:off x="392040" y="10509120"/>
                <a:ext cx="523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100 bp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>
                <a:off x="4573080" y="10788480"/>
                <a:ext cx="5029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31" name="" descr=""/>
              <p:cNvPicPr/>
              <p:nvPr/>
            </p:nvPicPr>
            <p:blipFill>
              <a:blip r:embed="rId13">
                <a:lum contrast="60000"/>
              </a:blip>
              <a:srcRect l="15051" t="28814" r="518" b="52520"/>
              <a:stretch/>
            </p:blipFill>
            <p:spPr>
              <a:xfrm>
                <a:off x="944280" y="9921960"/>
                <a:ext cx="3822120" cy="93348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sp>
        <p:nvSpPr>
          <p:cNvPr id="432" name=""/>
          <p:cNvSpPr/>
          <p:nvPr/>
        </p:nvSpPr>
        <p:spPr>
          <a:xfrm>
            <a:off x="204840" y="910440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6680160" y="806616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J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217440" y="1156320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5" name=""/>
          <p:cNvGrpSpPr/>
          <p:nvPr/>
        </p:nvGrpSpPr>
        <p:grpSpPr>
          <a:xfrm>
            <a:off x="6827760" y="2275560"/>
            <a:ext cx="4676760" cy="1971000"/>
            <a:chOff x="6827760" y="2275560"/>
            <a:chExt cx="4676760" cy="1971000"/>
          </a:xfrm>
        </p:grpSpPr>
        <p:sp>
          <p:nvSpPr>
            <p:cNvPr id="436" name=""/>
            <p:cNvSpPr/>
            <p:nvPr/>
          </p:nvSpPr>
          <p:spPr>
            <a:xfrm rot="18088800">
              <a:off x="7860960" y="2989080"/>
              <a:ext cx="86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 rot="18079200">
              <a:off x="9865800" y="2787840"/>
              <a:ext cx="1320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4304G&gt;A,</a:t>
              </a:r>
              <a:r>
                <a:rPr b="1" sz="800" spc="-1" strike="noStrike">
                  <a:solidFill>
                    <a:srgbClr val="000000"/>
                  </a:solidFill>
                  <a:latin typeface="Arial"/>
                </a:rPr>
                <a:t>Q1395Q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 flipV="1">
              <a:off x="9997920" y="2741400"/>
              <a:ext cx="43200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 flipV="1">
              <a:off x="9569520" y="2743200"/>
              <a:ext cx="4348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 flipV="1">
              <a:off x="9147240" y="2741400"/>
              <a:ext cx="433440" cy="718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 flipV="1">
              <a:off x="8740800" y="2743200"/>
              <a:ext cx="4316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 flipV="1">
              <a:off x="8331120" y="2743200"/>
              <a:ext cx="43488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 flipV="1">
              <a:off x="7915320" y="2739960"/>
              <a:ext cx="4316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 rot="18088800">
              <a:off x="8355960" y="3113640"/>
              <a:ext cx="577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 rot="18088800">
              <a:off x="8752320" y="3112560"/>
              <a:ext cx="576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3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 rot="18088800">
              <a:off x="9199800" y="3143160"/>
              <a:ext cx="50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 rot="18088800">
              <a:off x="9592920" y="3081600"/>
              <a:ext cx="647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C (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 rot="17980800">
              <a:off x="10425240" y="3048480"/>
              <a:ext cx="69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N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 flipV="1">
              <a:off x="10385280" y="2739960"/>
              <a:ext cx="435240" cy="71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7269120" y="3733920"/>
              <a:ext cx="506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7269120" y="403236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6827760" y="3613320"/>
              <a:ext cx="52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4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10952280" y="3672000"/>
              <a:ext cx="552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6837480" y="3917880"/>
              <a:ext cx="520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200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10499760" y="3805200"/>
              <a:ext cx="506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10939320" y="384480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ex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10496520" y="3978360"/>
              <a:ext cx="506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8" name="" descr=""/>
            <p:cNvPicPr/>
            <p:nvPr/>
          </p:nvPicPr>
          <p:blipFill>
            <a:blip r:embed="rId14"/>
            <a:stretch/>
          </p:blipFill>
          <p:spPr>
            <a:xfrm>
              <a:off x="7380360" y="3452760"/>
              <a:ext cx="3432240" cy="7938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59" name=""/>
          <p:cNvSpPr/>
          <p:nvPr/>
        </p:nvSpPr>
        <p:spPr>
          <a:xfrm>
            <a:off x="6669000" y="12241080"/>
            <a:ext cx="4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8T15:54:43Z</dcterms:created>
  <dc:creator>Eric Hahnen</dc:creator>
  <dc:description/>
  <dc:language>en-US</dc:language>
  <cp:lastModifiedBy>Eric Hahnen</cp:lastModifiedBy>
  <dcterms:modified xsi:type="dcterms:W3CDTF">2012-06-08T15:17:41Z</dcterms:modified>
  <cp:revision>15</cp:revision>
  <dc:subject/>
  <dc:title>Folie 1</dc:title>
</cp:coreProperties>
</file>